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580" autoAdjust="0"/>
    <p:restoredTop sz="94660"/>
  </p:normalViewPr>
  <p:slideViewPr>
    <p:cSldViewPr snapToGrid="0">
      <p:cViewPr>
        <p:scale>
          <a:sx n="77" d="100"/>
          <a:sy n="77" d="100"/>
        </p:scale>
        <p:origin x="2436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DA442-C116-464A-A135-E397F5090B42}" type="datetimeFigureOut">
              <a:rPr lang="it-IT" smtClean="0"/>
              <a:t>23/09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63E1D-AAE6-48DC-B1FF-B0ECE2A7C5C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565017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DA442-C116-464A-A135-E397F5090B42}" type="datetimeFigureOut">
              <a:rPr lang="it-IT" smtClean="0"/>
              <a:t>23/09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63E1D-AAE6-48DC-B1FF-B0ECE2A7C5C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938932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DA442-C116-464A-A135-E397F5090B42}" type="datetimeFigureOut">
              <a:rPr lang="it-IT" smtClean="0"/>
              <a:t>23/09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63E1D-AAE6-48DC-B1FF-B0ECE2A7C5C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261113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DA442-C116-464A-A135-E397F5090B42}" type="datetimeFigureOut">
              <a:rPr lang="it-IT" smtClean="0"/>
              <a:t>23/09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63E1D-AAE6-48DC-B1FF-B0ECE2A7C5C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713065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DA442-C116-464A-A135-E397F5090B42}" type="datetimeFigureOut">
              <a:rPr lang="it-IT" smtClean="0"/>
              <a:t>23/09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63E1D-AAE6-48DC-B1FF-B0ECE2A7C5C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654834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DA442-C116-464A-A135-E397F5090B42}" type="datetimeFigureOut">
              <a:rPr lang="it-IT" smtClean="0"/>
              <a:t>23/09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63E1D-AAE6-48DC-B1FF-B0ECE2A7C5C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97726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DA442-C116-464A-A135-E397F5090B42}" type="datetimeFigureOut">
              <a:rPr lang="it-IT" smtClean="0"/>
              <a:t>23/09/2021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63E1D-AAE6-48DC-B1FF-B0ECE2A7C5C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370387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DA442-C116-464A-A135-E397F5090B42}" type="datetimeFigureOut">
              <a:rPr lang="it-IT" smtClean="0"/>
              <a:t>23/09/2021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63E1D-AAE6-48DC-B1FF-B0ECE2A7C5C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651238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DA442-C116-464A-A135-E397F5090B42}" type="datetimeFigureOut">
              <a:rPr lang="it-IT" smtClean="0"/>
              <a:t>23/09/2021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63E1D-AAE6-48DC-B1FF-B0ECE2A7C5C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844353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DA442-C116-464A-A135-E397F5090B42}" type="datetimeFigureOut">
              <a:rPr lang="it-IT" smtClean="0"/>
              <a:t>23/09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63E1D-AAE6-48DC-B1FF-B0ECE2A7C5C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503309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 smtClean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DA442-C116-464A-A135-E397F5090B42}" type="datetimeFigureOut">
              <a:rPr lang="it-IT" smtClean="0"/>
              <a:t>23/09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663E1D-AAE6-48DC-B1FF-B0ECE2A7C5C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843086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EDA442-C116-464A-A135-E397F5090B42}" type="datetimeFigureOut">
              <a:rPr lang="it-IT" smtClean="0"/>
              <a:t>23/09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663E1D-AAE6-48DC-B1FF-B0ECE2A7C5C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704177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2918154" y="743140"/>
            <a:ext cx="11186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i="1" dirty="0" smtClean="0"/>
              <a:t>Figure S2</a:t>
            </a:r>
            <a:endParaRPr lang="it-IT" b="1" i="1" dirty="0"/>
          </a:p>
        </p:txBody>
      </p:sp>
      <p:sp>
        <p:nvSpPr>
          <p:cNvPr id="6" name="Rettangolo 5"/>
          <p:cNvSpPr/>
          <p:nvPr/>
        </p:nvSpPr>
        <p:spPr>
          <a:xfrm>
            <a:off x="150395" y="6368430"/>
            <a:ext cx="6557210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/>
              <a:t>Figure S2</a:t>
            </a:r>
            <a:r>
              <a:rPr lang="en-US" sz="1000" dirty="0"/>
              <a:t>. Dynamics and stability of the interaction of FABP3 with oleic acid, the native ligand.</a:t>
            </a:r>
            <a:r>
              <a:rPr lang="en-US" sz="1000" b="1" i="1" dirty="0"/>
              <a:t> (</a:t>
            </a:r>
            <a:r>
              <a:rPr lang="en-US" sz="1000" b="1" dirty="0"/>
              <a:t>A) </a:t>
            </a:r>
            <a:r>
              <a:rPr lang="en-US" sz="1000" dirty="0"/>
              <a:t>Number of clusters as a function of simulation time and their occupancy throughout the trajectory of the OLA-FABP3 complex. (</a:t>
            </a:r>
            <a:r>
              <a:rPr lang="en-US" sz="1000" b="1" dirty="0"/>
              <a:t>B)</a:t>
            </a:r>
            <a:r>
              <a:rPr lang="en-US" sz="1000" dirty="0"/>
              <a:t> Hydrogen bonds between peptide and receptor and their occupancy (%) along the simulation.  (</a:t>
            </a:r>
            <a:r>
              <a:rPr lang="en-US" sz="1000" b="1" dirty="0"/>
              <a:t>C) </a:t>
            </a:r>
            <a:r>
              <a:rPr lang="en-US" sz="1000" dirty="0"/>
              <a:t> Simulation snapshots of the OLA-FABP3 complex, taken at selected times of the MD trajectory. The residues of the receptor involved in the interaction with oleic acid are represented by </a:t>
            </a:r>
            <a:r>
              <a:rPr lang="en-US" sz="1000" i="1" dirty="0"/>
              <a:t>licorice </a:t>
            </a:r>
            <a:r>
              <a:rPr lang="en-US" sz="1000" dirty="0"/>
              <a:t>model. </a:t>
            </a:r>
            <a:r>
              <a:rPr lang="en-US" sz="1000" dirty="0" err="1"/>
              <a:t>Tufstin</a:t>
            </a:r>
            <a:r>
              <a:rPr lang="en-US" sz="1000" dirty="0"/>
              <a:t> is </a:t>
            </a:r>
            <a:r>
              <a:rPr lang="en-US" sz="1000" dirty="0" err="1"/>
              <a:t>coloured</a:t>
            </a:r>
            <a:r>
              <a:rPr lang="en-US" sz="1000" dirty="0"/>
              <a:t> in green and depicted in </a:t>
            </a:r>
            <a:r>
              <a:rPr lang="en-US" sz="1000" i="1" dirty="0"/>
              <a:t>licorice </a:t>
            </a:r>
            <a:r>
              <a:rPr lang="en-US" sz="1000" dirty="0"/>
              <a:t>model. The black dashed lines show the hydrogen bonds. The representative structure of the most populated cluster and its percentage of occupancy along the trajectory is also indicated.</a:t>
            </a:r>
            <a:endParaRPr lang="it-IT" sz="1000" dirty="0"/>
          </a:p>
          <a:p>
            <a:pPr algn="just"/>
            <a:r>
              <a:rPr lang="en-US" sz="1000" dirty="0">
                <a:solidFill>
                  <a:srgbClr val="FF0000"/>
                </a:solidFill>
              </a:rPr>
              <a:t>The interaction mode of OLA with FABP3 was simulated as a reference. The clustering of the structural conformations adopted by the complex during the MD simulation showed that the natural ligand forms a stable complex with its receptors for approximatively 98% of their trajectory (panels A and B) and that such stability is mainly due to the formation of persistent H-bonds (panels C).</a:t>
            </a:r>
            <a:endParaRPr lang="it-IT" sz="1000" dirty="0">
              <a:solidFill>
                <a:srgbClr val="FF0000"/>
              </a:solidFill>
              <a:latin typeface="Palatino Linotype" panose="02040502050505030304" pitchFamily="18" charset="0"/>
            </a:endParaRPr>
          </a:p>
        </p:txBody>
      </p:sp>
      <p:pic>
        <p:nvPicPr>
          <p:cNvPr id="2" name="Immagin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8628" y="1462103"/>
            <a:ext cx="6490864" cy="44627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9426323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207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i Office</vt:lpstr>
      <vt:lpstr>Presentazione standard di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teresa</dc:creator>
  <cp:lastModifiedBy>Lico</cp:lastModifiedBy>
  <cp:revision>2</cp:revision>
  <dcterms:created xsi:type="dcterms:W3CDTF">2021-09-02T07:55:39Z</dcterms:created>
  <dcterms:modified xsi:type="dcterms:W3CDTF">2021-09-23T10:09:24Z</dcterms:modified>
</cp:coreProperties>
</file>